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20" d="100"/>
          <a:sy n="120" d="100"/>
        </p:scale>
        <p:origin x="-942" y="33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E011C-A7A7-4F81-9ABF-33DD3F616DB3}" type="datetimeFigureOut">
              <a:rPr lang="en-NZ" smtClean="0"/>
              <a:pPr/>
              <a:t>1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292A2-92DE-4A05-A56B-32FCF165E7EE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90831" y="182880"/>
            <a:ext cx="3856383" cy="8753334"/>
            <a:chOff x="190831" y="182880"/>
            <a:chExt cx="3856383" cy="8753334"/>
          </a:xfrm>
        </p:grpSpPr>
        <p:grpSp>
          <p:nvGrpSpPr>
            <p:cNvPr id="12" name="Group 11"/>
            <p:cNvGrpSpPr/>
            <p:nvPr/>
          </p:nvGrpSpPr>
          <p:grpSpPr>
            <a:xfrm>
              <a:off x="214689" y="190738"/>
              <a:ext cx="3729158" cy="7927547"/>
              <a:chOff x="214689" y="190738"/>
              <a:chExt cx="3729158" cy="7927547"/>
            </a:xfrm>
          </p:grpSpPr>
          <p:pic>
            <p:nvPicPr>
              <p:cNvPr id="4" name="Picture 3" descr="linearview2_Br18.png"/>
              <p:cNvPicPr>
                <a:picLocks noChangeAspect="1"/>
              </p:cNvPicPr>
              <p:nvPr/>
            </p:nvPicPr>
            <p:blipFill>
              <a:blip r:embed="rId2" cstate="print"/>
              <a:srcRect b="40574"/>
              <a:stretch>
                <a:fillRect/>
              </a:stretch>
            </p:blipFill>
            <p:spPr>
              <a:xfrm>
                <a:off x="238492" y="1928664"/>
                <a:ext cx="3694563" cy="16561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Picture 7" descr="linearview1_Br18.png"/>
              <p:cNvPicPr>
                <a:picLocks noChangeAspect="1"/>
              </p:cNvPicPr>
              <p:nvPr/>
            </p:nvPicPr>
            <p:blipFill>
              <a:blip r:embed="rId3" cstate="print"/>
              <a:srcRect b="39411"/>
              <a:stretch>
                <a:fillRect/>
              </a:stretch>
            </p:blipFill>
            <p:spPr>
              <a:xfrm>
                <a:off x="238492" y="190738"/>
                <a:ext cx="3694564" cy="17286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Picture 8" descr="LinearviewH20.png"/>
              <p:cNvPicPr>
                <a:picLocks noChangeAspect="1"/>
              </p:cNvPicPr>
              <p:nvPr/>
            </p:nvPicPr>
            <p:blipFill>
              <a:blip r:embed="rId4" cstate="print"/>
              <a:srcRect b="39622"/>
              <a:stretch>
                <a:fillRect/>
              </a:stretch>
            </p:blipFill>
            <p:spPr>
              <a:xfrm>
                <a:off x="238492" y="3592849"/>
                <a:ext cx="3694564" cy="18219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" name="Picture 9" descr="linearviewH14.png"/>
              <p:cNvPicPr>
                <a:picLocks noChangeAspect="1"/>
              </p:cNvPicPr>
              <p:nvPr/>
            </p:nvPicPr>
            <p:blipFill>
              <a:blip r:embed="rId5" cstate="print"/>
              <a:srcRect b="36981"/>
              <a:stretch>
                <a:fillRect/>
              </a:stretch>
            </p:blipFill>
            <p:spPr>
              <a:xfrm>
                <a:off x="242495" y="5417400"/>
                <a:ext cx="3693400" cy="174250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" name="Picture 10" descr="linearview2_Br18.png"/>
              <p:cNvPicPr>
                <a:picLocks noChangeAspect="1"/>
              </p:cNvPicPr>
              <p:nvPr/>
            </p:nvPicPr>
            <p:blipFill>
              <a:blip r:embed="rId6" cstate="print"/>
              <a:srcRect l="1971" t="68711" r="8870" b="3844"/>
              <a:stretch>
                <a:fillRect/>
              </a:stretch>
            </p:blipFill>
            <p:spPr>
              <a:xfrm>
                <a:off x="214689" y="7171201"/>
                <a:ext cx="3729158" cy="947084"/>
              </a:xfrm>
              <a:prstGeom prst="rect">
                <a:avLst/>
              </a:prstGeom>
            </p:spPr>
          </p:pic>
        </p:grpSp>
        <p:sp>
          <p:nvSpPr>
            <p:cNvPr id="13" name="TextBox 12"/>
            <p:cNvSpPr txBox="1"/>
            <p:nvPr/>
          </p:nvSpPr>
          <p:spPr>
            <a:xfrm>
              <a:off x="190831" y="8428383"/>
              <a:ext cx="3856383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b="1" dirty="0" smtClean="0"/>
                <a:t>Additional file 3</a:t>
              </a:r>
              <a:r>
                <a:rPr lang="en-NZ" sz="900" dirty="0" smtClean="0"/>
                <a:t>: </a:t>
              </a:r>
              <a:r>
                <a:rPr lang="en-NZ" sz="900" dirty="0" smtClean="0"/>
                <a:t>Putative phage sequences identified in Antarctic </a:t>
              </a:r>
              <a:r>
                <a:rPr lang="en-NZ" sz="900" i="1" dirty="0" smtClean="0"/>
                <a:t>Arthrobacter</a:t>
              </a:r>
              <a:r>
                <a:rPr lang="en-NZ" sz="900" dirty="0" smtClean="0"/>
                <a:t> strains Br18 (a, b); H20 (c); H14 (d) by phage search tool, PHAST </a:t>
              </a:r>
              <a:r>
                <a:rPr lang="en-NZ" sz="900" dirty="0" smtClean="0"/>
                <a:t>[24].</a:t>
              </a:r>
              <a:endParaRPr lang="en-NZ" sz="9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705308" y="182880"/>
              <a:ext cx="2385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b="1" dirty="0" smtClean="0"/>
                <a:t>a</a:t>
              </a:r>
              <a:endParaRPr lang="en-NZ" sz="9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06633" y="3595315"/>
              <a:ext cx="2385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b="1" dirty="0"/>
                <a:t>c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00008" y="1934818"/>
              <a:ext cx="2385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b="1" dirty="0" smtClean="0"/>
                <a:t>b</a:t>
              </a:r>
              <a:endParaRPr lang="en-NZ" sz="9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701335" y="5410827"/>
              <a:ext cx="2385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900" b="1" dirty="0"/>
                <a:t>d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39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dso006</dc:creator>
  <cp:lastModifiedBy>mdso006</cp:lastModifiedBy>
  <cp:revision>2</cp:revision>
  <dcterms:created xsi:type="dcterms:W3CDTF">2013-11-29T23:53:16Z</dcterms:created>
  <dcterms:modified xsi:type="dcterms:W3CDTF">2014-06-01T07:49:43Z</dcterms:modified>
</cp:coreProperties>
</file>